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31" r:id="rId2"/>
  </p:sldIdLst>
  <p:sldSz cx="6858000" cy="9906000" type="A4"/>
  <p:notesSz cx="6799263" cy="9929813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372" userDrawn="1">
          <p15:clr>
            <a:srgbClr val="A4A3A4"/>
          </p15:clr>
        </p15:guide>
        <p15:guide id="2" pos="18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245E9"/>
    <a:srgbClr val="FF0000"/>
    <a:srgbClr val="3030FE"/>
    <a:srgbClr val="00C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898" autoAdjust="0"/>
    <p:restoredTop sz="96349" autoAdjust="0"/>
  </p:normalViewPr>
  <p:slideViewPr>
    <p:cSldViewPr snapToGrid="0">
      <p:cViewPr>
        <p:scale>
          <a:sx n="98" d="100"/>
          <a:sy n="98" d="100"/>
        </p:scale>
        <p:origin x="3012" y="-1074"/>
      </p:cViewPr>
      <p:guideLst>
        <p:guide orient="horz" pos="2372"/>
        <p:guide pos="18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1275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8F970C8-CFE4-45CB-B1DE-2B1C53475BBD}" type="datetimeFigureOut">
              <a:rPr lang="fr-FR" smtClean="0"/>
              <a:t>03/12/2025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9337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79450" y="4778375"/>
            <a:ext cx="5440363" cy="391001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31338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1275" y="9431338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65E2978-9DEE-4F4A-8890-B203F7D3B1C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503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66837-3F11-456D-A21E-E6EF219DA248}" type="datetimeFigureOut">
              <a:rPr lang="fr-FR" smtClean="0"/>
              <a:t>03/12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8ACE5-4442-4D5E-BDE5-68F0EB4ACBB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244076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66837-3F11-456D-A21E-E6EF219DA248}" type="datetimeFigureOut">
              <a:rPr lang="fr-FR" smtClean="0"/>
              <a:t>03/12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8ACE5-4442-4D5E-BDE5-68F0EB4ACBB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263452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66837-3F11-456D-A21E-E6EF219DA248}" type="datetimeFigureOut">
              <a:rPr lang="fr-FR" smtClean="0"/>
              <a:t>03/12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8ACE5-4442-4D5E-BDE5-68F0EB4ACBB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788646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66837-3F11-456D-A21E-E6EF219DA248}" type="datetimeFigureOut">
              <a:rPr lang="fr-FR" smtClean="0"/>
              <a:t>03/12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8ACE5-4442-4D5E-BDE5-68F0EB4ACBB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875600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66837-3F11-456D-A21E-E6EF219DA248}" type="datetimeFigureOut">
              <a:rPr lang="fr-FR" smtClean="0"/>
              <a:t>03/12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8ACE5-4442-4D5E-BDE5-68F0EB4ACBB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593828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66837-3F11-456D-A21E-E6EF219DA248}" type="datetimeFigureOut">
              <a:rPr lang="fr-FR" smtClean="0"/>
              <a:t>03/12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8ACE5-4442-4D5E-BDE5-68F0EB4ACBB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390059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66837-3F11-456D-A21E-E6EF219DA248}" type="datetimeFigureOut">
              <a:rPr lang="fr-FR" smtClean="0"/>
              <a:t>03/12/2025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8ACE5-4442-4D5E-BDE5-68F0EB4ACBB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447582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66837-3F11-456D-A21E-E6EF219DA248}" type="datetimeFigureOut">
              <a:rPr lang="fr-FR" smtClean="0"/>
              <a:t>03/12/2025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8ACE5-4442-4D5E-BDE5-68F0EB4ACBB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338220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66837-3F11-456D-A21E-E6EF219DA248}" type="datetimeFigureOut">
              <a:rPr lang="fr-FR" smtClean="0"/>
              <a:t>03/12/2025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8ACE5-4442-4D5E-BDE5-68F0EB4ACBB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594262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66837-3F11-456D-A21E-E6EF219DA248}" type="datetimeFigureOut">
              <a:rPr lang="fr-FR" smtClean="0"/>
              <a:t>03/12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8ACE5-4442-4D5E-BDE5-68F0EB4ACBB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496926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966837-3F11-456D-A21E-E6EF219DA248}" type="datetimeFigureOut">
              <a:rPr lang="fr-FR" smtClean="0"/>
              <a:t>03/12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8ACE5-4442-4D5E-BDE5-68F0EB4ACBB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80624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966837-3F11-456D-A21E-E6EF219DA248}" type="datetimeFigureOut">
              <a:rPr lang="fr-FR" smtClean="0"/>
              <a:t>03/12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A8ACE5-4442-4D5E-BDE5-68F0EB4ACBB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349597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3">
            <a:extLst>
              <a:ext uri="{FF2B5EF4-FFF2-40B4-BE49-F238E27FC236}">
                <a16:creationId xmlns:a16="http://schemas.microsoft.com/office/drawing/2014/main" id="{C4785AA3-95EA-4E2E-8FA2-B97AB5B569F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16120887"/>
              </p:ext>
            </p:extLst>
          </p:nvPr>
        </p:nvGraphicFramePr>
        <p:xfrm>
          <a:off x="372521" y="468014"/>
          <a:ext cx="5915024" cy="2705989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781558">
                  <a:extLst>
                    <a:ext uri="{9D8B030D-6E8A-4147-A177-3AD203B41FA5}">
                      <a16:colId xmlns:a16="http://schemas.microsoft.com/office/drawing/2014/main" val="656862523"/>
                    </a:ext>
                  </a:extLst>
                </a:gridCol>
                <a:gridCol w="1175954">
                  <a:extLst>
                    <a:ext uri="{9D8B030D-6E8A-4147-A177-3AD203B41FA5}">
                      <a16:colId xmlns:a16="http://schemas.microsoft.com/office/drawing/2014/main" val="3700435084"/>
                    </a:ext>
                  </a:extLst>
                </a:gridCol>
                <a:gridCol w="1478756">
                  <a:extLst>
                    <a:ext uri="{9D8B030D-6E8A-4147-A177-3AD203B41FA5}">
                      <a16:colId xmlns:a16="http://schemas.microsoft.com/office/drawing/2014/main" val="1011757070"/>
                    </a:ext>
                  </a:extLst>
                </a:gridCol>
                <a:gridCol w="1478756">
                  <a:extLst>
                    <a:ext uri="{9D8B030D-6E8A-4147-A177-3AD203B41FA5}">
                      <a16:colId xmlns:a16="http://schemas.microsoft.com/office/drawing/2014/main" val="1550268339"/>
                    </a:ext>
                  </a:extLst>
                </a:gridCol>
              </a:tblGrid>
              <a:tr h="243878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</a:rPr>
                        <a:t> 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89" marR="67989" marT="0" marB="0"/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Inhibition [µM]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89" marR="67989" marT="0" marB="0"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42477220"/>
                  </a:ext>
                </a:extLst>
              </a:tr>
              <a:tr h="243878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compound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89" marR="6798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LSD1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89" marR="6798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MAO A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89" marR="6798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MAO B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89" marR="67989" marT="0" marB="0" anchor="ctr"/>
                </a:tc>
                <a:extLst>
                  <a:ext uri="{0D108BD9-81ED-4DB2-BD59-A6C34878D82A}">
                    <a16:rowId xmlns:a16="http://schemas.microsoft.com/office/drawing/2014/main" val="3537882696"/>
                  </a:ext>
                </a:extLst>
              </a:tr>
              <a:tr h="243878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NT24 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89" marR="6798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0.06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89" marR="6798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0.25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89" marR="6798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76 % at 100 µM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89" marR="67989" marT="0" marB="0" anchor="ctr"/>
                </a:tc>
                <a:extLst>
                  <a:ext uri="{0D108BD9-81ED-4DB2-BD59-A6C34878D82A}">
                    <a16:rowId xmlns:a16="http://schemas.microsoft.com/office/drawing/2014/main" val="326679012"/>
                  </a:ext>
                </a:extLst>
              </a:tr>
              <a:tr h="243878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NT29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89" marR="6798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0.09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89" marR="6798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0.22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89" marR="6798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73% at 100 µM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89" marR="67989" marT="0" marB="0" anchor="ctr"/>
                </a:tc>
                <a:extLst>
                  <a:ext uri="{0D108BD9-81ED-4DB2-BD59-A6C34878D82A}">
                    <a16:rowId xmlns:a16="http://schemas.microsoft.com/office/drawing/2014/main" val="2285228848"/>
                  </a:ext>
                </a:extLst>
              </a:tr>
              <a:tr h="243878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AAB175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89" marR="6798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0.14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89" marR="6798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0.33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89" marR="6798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n.i. at 100 µM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89" marR="67989" marT="0" marB="0" anchor="ctr"/>
                </a:tc>
                <a:extLst>
                  <a:ext uri="{0D108BD9-81ED-4DB2-BD59-A6C34878D82A}">
                    <a16:rowId xmlns:a16="http://schemas.microsoft.com/office/drawing/2014/main" val="1775507017"/>
                  </a:ext>
                </a:extLst>
              </a:tr>
              <a:tr h="243878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AAB167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89" marR="6798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0.13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89" marR="6798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0.53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89" marR="6798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n.i. at 100 µM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89" marR="67989" marT="0" marB="0" anchor="ctr"/>
                </a:tc>
                <a:extLst>
                  <a:ext uri="{0D108BD9-81ED-4DB2-BD59-A6C34878D82A}">
                    <a16:rowId xmlns:a16="http://schemas.microsoft.com/office/drawing/2014/main" val="1045944933"/>
                  </a:ext>
                </a:extLst>
              </a:tr>
              <a:tr h="243878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PB17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89" marR="6798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0.06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89" marR="6798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0.44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89" marR="6798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43% at 100 µM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89" marR="67989" marT="0" marB="0" anchor="ctr"/>
                </a:tc>
                <a:extLst>
                  <a:ext uri="{0D108BD9-81ED-4DB2-BD59-A6C34878D82A}">
                    <a16:rowId xmlns:a16="http://schemas.microsoft.com/office/drawing/2014/main" val="3106975986"/>
                  </a:ext>
                </a:extLst>
              </a:tr>
              <a:tr h="243878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AAB243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89" marR="6798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0.06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89" marR="6798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0.50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89" marR="6798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</a:rPr>
                        <a:t>85% at 100 µM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89" marR="67989" marT="0" marB="0" anchor="ctr"/>
                </a:tc>
                <a:extLst>
                  <a:ext uri="{0D108BD9-81ED-4DB2-BD59-A6C34878D82A}">
                    <a16:rowId xmlns:a16="http://schemas.microsoft.com/office/drawing/2014/main" val="2272367168"/>
                  </a:ext>
                </a:extLst>
              </a:tr>
              <a:tr h="243878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AAB252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89" marR="6798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0.05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89" marR="6798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1.69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89" marR="6798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23% at 100 µM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89" marR="67989" marT="0" marB="0" anchor="ctr"/>
                </a:tc>
                <a:extLst>
                  <a:ext uri="{0D108BD9-81ED-4DB2-BD59-A6C34878D82A}">
                    <a16:rowId xmlns:a16="http://schemas.microsoft.com/office/drawing/2014/main" val="432522751"/>
                  </a:ext>
                </a:extLst>
              </a:tr>
              <a:tr h="243878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AAB20 (neg. control)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89" marR="6798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0.09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89" marR="6798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0.17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89" marR="6798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14.25 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89" marR="67989" marT="0" marB="0" anchor="ctr"/>
                </a:tc>
                <a:extLst>
                  <a:ext uri="{0D108BD9-81ED-4DB2-BD59-A6C34878D82A}">
                    <a16:rowId xmlns:a16="http://schemas.microsoft.com/office/drawing/2014/main" val="2529363364"/>
                  </a:ext>
                </a:extLst>
              </a:tr>
              <a:tr h="243878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AAB362 (neg.control)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89" marR="6798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78.0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89" marR="6798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16% at 1 mM</a:t>
                      </a:r>
                      <a:endParaRPr lang="fr-FR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89" marR="67989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200" dirty="0" err="1">
                          <a:effectLst/>
                        </a:rPr>
                        <a:t>n.i.</a:t>
                      </a:r>
                      <a:r>
                        <a:rPr lang="en-US" sz="1200" dirty="0">
                          <a:effectLst/>
                        </a:rPr>
                        <a:t> at 100 µM</a:t>
                      </a:r>
                      <a:endParaRPr lang="fr-FR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989" marR="67989" marT="0" marB="0" anchor="ctr"/>
                </a:tc>
                <a:extLst>
                  <a:ext uri="{0D108BD9-81ED-4DB2-BD59-A6C34878D82A}">
                    <a16:rowId xmlns:a16="http://schemas.microsoft.com/office/drawing/2014/main" val="823122925"/>
                  </a:ext>
                </a:extLst>
              </a:tr>
            </a:tbl>
          </a:graphicData>
        </a:graphic>
      </p:graphicFrame>
      <p:sp>
        <p:nvSpPr>
          <p:cNvPr id="5" name="ZoneTexte 4">
            <a:extLst>
              <a:ext uri="{FF2B5EF4-FFF2-40B4-BE49-F238E27FC236}">
                <a16:creationId xmlns:a16="http://schemas.microsoft.com/office/drawing/2014/main" id="{6136FE71-9FD9-41B4-86E1-38B26A0CD80C}"/>
              </a:ext>
            </a:extLst>
          </p:cNvPr>
          <p:cNvSpPr txBox="1"/>
          <p:nvPr/>
        </p:nvSpPr>
        <p:spPr>
          <a:xfrm>
            <a:off x="168662" y="8890337"/>
            <a:ext cx="6504512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3: Overview of the i</a:t>
            </a:r>
            <a:r>
              <a:rPr lang="en-US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 vitro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valuation of LSD1 inhibition using the </a:t>
            </a:r>
            <a:r>
              <a:rPr lang="en-US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mplex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d assay.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assess selectivity, inhibitory activity of the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omologes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AO-A and MAO-B were measured using a luminescence-based assay. Note that AAB-252 has an increased IC50 for MAO A (1.69 µM) due to the sulfonamide structure AAB20 is an LSD1 inhibitor without hydrophobic tag or linker. </a:t>
            </a:r>
          </a:p>
        </p:txBody>
      </p:sp>
    </p:spTree>
    <p:extLst>
      <p:ext uri="{BB962C8B-B14F-4D97-AF65-F5344CB8AC3E}">
        <p14:creationId xmlns:p14="http://schemas.microsoft.com/office/powerpoint/2010/main" val="212778823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89</TotalTime>
  <Words>167</Words>
  <Application>Microsoft Office PowerPoint</Application>
  <PresentationFormat>Format A4 (210 x 297 mm)</PresentationFormat>
  <Paragraphs>4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arsig</dc:creator>
  <cp:lastModifiedBy>Hervé  LECOEUR</cp:lastModifiedBy>
  <cp:revision>135</cp:revision>
  <cp:lastPrinted>2025-12-03T09:07:27Z</cp:lastPrinted>
  <dcterms:modified xsi:type="dcterms:W3CDTF">2025-12-03T10:28:08Z</dcterms:modified>
</cp:coreProperties>
</file>